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72AFBB-AE2B-4C85-81C7-73EE77C69C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D818C2-6B95-4CA5-8FC9-853972F041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F6526E-B583-4E71-8E12-80CE34B4579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B04F3D-C2EE-4EF6-A1CF-36F5CCB3E26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52AE24-4BD1-4F9F-A6BE-A09307944A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3F67A2-EE7A-4060-9BEE-A6E349B2D7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52C141-6BDF-4A87-9F1F-57D2B24201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F67D38-1D46-46D2-B389-982DCEE390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2D4F11-BE8A-4D9E-B191-DE593E190B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2FCBD7-1F03-45FB-8DBA-3AFB9BBD13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B78A2E-CDBE-4851-8A49-F9DFB46A35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ACBB45-C6DA-4179-BE3F-06D1084E47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02DDCD-EB0F-4BC5-9AAB-F8D50C93B2A0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feld 3"/>
          <p:cNvSpPr/>
          <p:nvPr/>
        </p:nvSpPr>
        <p:spPr>
          <a:xfrm>
            <a:off x="222120" y="271440"/>
            <a:ext cx="8508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Calibri"/>
                <a:ea typeface="Arial"/>
              </a:rPr>
              <a:t>Supplementary Table 1. </a:t>
            </a:r>
            <a:r>
              <a:rPr b="0" lang="de-DE" sz="1200" spc="-1" strike="noStrike">
                <a:solidFill>
                  <a:srgbClr val="000000"/>
                </a:solidFill>
                <a:latin typeface="Calibri"/>
                <a:ea typeface="Arial"/>
              </a:rPr>
              <a:t>The 10 most significantly activated transcription factors in rat PAs (Dataset 1) obtained using the Ingenuity Pathway Analysis software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5" descr=""/>
          <p:cNvPicPr/>
          <p:nvPr/>
        </p:nvPicPr>
        <p:blipFill>
          <a:blip r:embed="rId1"/>
          <a:stretch/>
        </p:blipFill>
        <p:spPr>
          <a:xfrm>
            <a:off x="222120" y="952560"/>
            <a:ext cx="8645760" cy="3771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10T09:51:53Z</dcterms:created>
  <dc:creator>natalia.pellegata</dc:creator>
  <dc:description/>
  <dc:language>en-US</dc:language>
  <cp:lastModifiedBy>natalia.pellegata</cp:lastModifiedBy>
  <dcterms:modified xsi:type="dcterms:W3CDTF">2013-06-10T09:52:18Z</dcterms:modified>
  <cp:revision>1</cp:revision>
  <dc:subject/>
  <dc:title>PowerPoint-Präsentation</dc:title>
</cp:coreProperties>
</file>